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0" r:id="rId3"/>
    <p:sldId id="271" r:id="rId4"/>
    <p:sldId id="272" r:id="rId5"/>
    <p:sldId id="273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31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417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8517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8615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5051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580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2885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28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212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77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7004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6449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63329" y="1596257"/>
            <a:ext cx="9144000" cy="1655762"/>
          </a:xfrm>
        </p:spPr>
        <p:txBody>
          <a:bodyPr/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65933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/>
          <p:cNvSpPr txBox="1"/>
          <p:nvPr/>
        </p:nvSpPr>
        <p:spPr>
          <a:xfrm>
            <a:off x="167147" y="5791931"/>
            <a:ext cx="1143491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-1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thirtee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NRT1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shoot and in root across the N treatment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9221" y="-119792"/>
            <a:ext cx="5725397" cy="59117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42734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6742" y="135187"/>
            <a:ext cx="4857358" cy="576316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58357" y="6055663"/>
            <a:ext cx="1086464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-2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nine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NRT1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shoot and in root across the N treatment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7281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6090" y="934830"/>
            <a:ext cx="5277281" cy="5387659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93290" y="6068571"/>
            <a:ext cx="1086464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-3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six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NRT1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two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NRT2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shoot and in root across the N treatment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7203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0300" y="528930"/>
            <a:ext cx="4467184" cy="4587134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93290" y="6068571"/>
            <a:ext cx="1086464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-4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five </a:t>
            </a:r>
            <a:r>
              <a:rPr lang="en-US" altLang="zh-CN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AMT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shoot and in root across the N treatment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085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96</TotalTime>
  <Words>74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ZA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Hua</dc:creator>
  <cp:lastModifiedBy>MDPI</cp:lastModifiedBy>
  <cp:revision>60</cp:revision>
  <dcterms:created xsi:type="dcterms:W3CDTF">2020-01-05T03:20:41Z</dcterms:created>
  <dcterms:modified xsi:type="dcterms:W3CDTF">2020-09-17T03:46:03Z</dcterms:modified>
</cp:coreProperties>
</file>